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95" autoAdjust="0"/>
  </p:normalViewPr>
  <p:slideViewPr>
    <p:cSldViewPr>
      <p:cViewPr varScale="1">
        <p:scale>
          <a:sx n="97" d="100"/>
          <a:sy n="97" d="100"/>
        </p:scale>
        <p:origin x="30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55464" y="914400"/>
            <a:ext cx="6035040" cy="1916430"/>
            <a:chOff x="1584960" y="3188970"/>
            <a:chExt cx="6035040" cy="1916430"/>
          </a:xfrm>
        </p:grpSpPr>
        <p:grpSp>
          <p:nvGrpSpPr>
            <p:cNvPr id="6" name="Group 5"/>
            <p:cNvGrpSpPr/>
            <p:nvPr/>
          </p:nvGrpSpPr>
          <p:grpSpPr>
            <a:xfrm>
              <a:off x="1584960" y="3188970"/>
              <a:ext cx="6035040" cy="1916430"/>
              <a:chOff x="1584960" y="3188970"/>
              <a:chExt cx="6035040" cy="1916430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1584960" y="3188970"/>
                <a:ext cx="6035040" cy="1916430"/>
                <a:chOff x="1584960" y="2807970"/>
                <a:chExt cx="6035040" cy="1916430"/>
              </a:xfrm>
            </p:grpSpPr>
            <p:sp>
              <p:nvSpPr>
                <p:cNvPr id="31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1584960" y="2807970"/>
                  <a:ext cx="6035040" cy="191643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just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n-US" sz="1200" dirty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MERGGYGSTEGGRYGSDTGGYGGSDETTRYGTDTGGYGTTGGGGYGSTETGGGYGAGGAGGGA</a:t>
                  </a:r>
                  <a:endParaRPr lang="en-IN" sz="1100" dirty="0">
                    <a:effectLst/>
                    <a:latin typeface="Courier New" panose="02070309020205020404" pitchFamily="49" charset="0"/>
                    <a:ea typeface="Times New Roman"/>
                    <a:cs typeface="Courier New" panose="02070309020205020404" pitchFamily="49" charset="0"/>
                  </a:endParaRPr>
                </a:p>
                <a:p>
                  <a:pPr algn="just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n-US" sz="1200" dirty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YGGGLSEYNTTGGFGYGGTETKRYGEEEGGYKKGGIGSGSYESEEPAR</a:t>
                  </a:r>
                  <a:r>
                    <a:rPr lang="en-US" sz="1200" b="1" u="sng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DYDKEEKHHKHLEQL</a:t>
                  </a:r>
                  <a:endParaRPr lang="en-IN" sz="1100" dirty="0">
                    <a:effectLst/>
                    <a:latin typeface="Courier New" panose="02070309020205020404" pitchFamily="49" charset="0"/>
                    <a:ea typeface="Times New Roman"/>
                    <a:cs typeface="Courier New" panose="02070309020205020404" pitchFamily="49" charset="0"/>
                  </a:endParaRPr>
                </a:p>
                <a:p>
                  <a:pPr algn="just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n-US" sz="1200" b="1" u="sng" dirty="0" smtClean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GGLGAV</a:t>
                  </a:r>
                  <a:r>
                    <a:rPr lang="en-US" sz="1200" b="1" u="sng" dirty="0" smtClean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S</a:t>
                  </a:r>
                  <a:r>
                    <a:rPr lang="en-US" sz="1200" b="1" u="sng" dirty="0" smtClean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GAYAL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Y</a:t>
                  </a:r>
                  <a:r>
                    <a:rPr lang="en-US" sz="1200" b="1" u="sng" dirty="0" smtClean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KH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</a:t>
                  </a:r>
                  <a:r>
                    <a:rPr lang="en-US" sz="1200" b="1" u="sng" dirty="0" smtClean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KKDPE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N</a:t>
                  </a:r>
                  <a:r>
                    <a:rPr lang="en-US" sz="1200" b="1" u="sng" dirty="0" smtClean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HRHKI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E</a:t>
                  </a:r>
                  <a:r>
                    <a:rPr lang="en-US" sz="1200" b="1" u="sng" dirty="0" smtClean="0">
                      <a:solidFill>
                        <a:srgbClr val="000099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V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S</a:t>
                  </a:r>
                  <a:r>
                    <a:rPr lang="en-US" sz="1200" b="1" u="sng" dirty="0" smtClean="0">
                      <a:solidFill>
                        <a:srgbClr val="000099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V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G</a:t>
                  </a:r>
                  <a:r>
                    <a:rPr lang="en-US" sz="1200" b="1" u="sng" dirty="0" smtClean="0">
                      <a:solidFill>
                        <a:srgbClr val="000099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V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</a:t>
                  </a:r>
                  <a:r>
                    <a:rPr lang="en-US" sz="1200" b="1" u="sng" dirty="0" smtClean="0">
                      <a:solidFill>
                        <a:srgbClr val="000099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SGGFAFHEHHQKKD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V</a:t>
                  </a:r>
                  <a:r>
                    <a:rPr lang="en-US" sz="1200" b="1" u="sng" dirty="0" smtClean="0">
                      <a:solidFill>
                        <a:srgbClr val="000099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K</a:t>
                  </a: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DR</a:t>
                  </a:r>
                  <a:r>
                    <a:rPr lang="en-US" sz="1200" b="1" u="sng" dirty="0" smtClean="0">
                      <a:solidFill>
                        <a:srgbClr val="7030A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E</a:t>
                  </a:r>
                </a:p>
                <a:p>
                  <a:pPr algn="just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n-US" sz="1200" b="1" u="sng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A</a:t>
                  </a:r>
                  <a:r>
                    <a:rPr lang="en-US" sz="1200" dirty="0" smtClean="0">
                      <a:solidFill>
                        <a:srgbClr val="7030A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E</a:t>
                  </a:r>
                  <a:r>
                    <a:rPr lang="en-US" sz="1200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S</a:t>
                  </a:r>
                  <a:r>
                    <a:rPr lang="en-US" sz="1200" dirty="0" smtClean="0">
                      <a:solidFill>
                        <a:srgbClr val="7030A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GK</a:t>
                  </a:r>
                  <a:r>
                    <a:rPr lang="en-US" sz="1200" dirty="0" smtClean="0"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EKK</a:t>
                  </a:r>
                  <a:r>
                    <a:rPr lang="en-US" sz="1200" dirty="0" smtClean="0">
                      <a:solidFill>
                        <a:srgbClr val="7030A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HHFF</a:t>
                  </a:r>
                  <a:r>
                    <a:rPr lang="en-US" sz="1200" dirty="0">
                      <a:solidFill>
                        <a:srgbClr val="7030A0"/>
                      </a:solidFill>
                      <a:effectLst/>
                      <a:latin typeface="Courier New" panose="02070309020205020404" pitchFamily="49" charset="0"/>
                      <a:ea typeface="Times New Roman"/>
                      <a:cs typeface="Courier New" panose="02070309020205020404" pitchFamily="49" charset="0"/>
                    </a:rPr>
                    <a:t>*</a:t>
                  </a:r>
                  <a:endParaRPr lang="en-IN" sz="1100" dirty="0">
                    <a:effectLst/>
                    <a:latin typeface="Courier New" panose="02070309020205020404" pitchFamily="49" charset="0"/>
                    <a:ea typeface="Times New Roman"/>
                    <a:cs typeface="Courier New" panose="02070309020205020404" pitchFamily="49" charset="0"/>
                  </a:endParaRPr>
                </a:p>
              </p:txBody>
            </p:sp>
            <p:grpSp>
              <p:nvGrpSpPr>
                <p:cNvPr id="32" name="Group 31"/>
                <p:cNvGrpSpPr/>
                <p:nvPr/>
              </p:nvGrpSpPr>
              <p:grpSpPr>
                <a:xfrm>
                  <a:off x="1699260" y="3311723"/>
                  <a:ext cx="5787390" cy="483037"/>
                  <a:chOff x="1699260" y="3311723"/>
                  <a:chExt cx="5787390" cy="483037"/>
                </a:xfrm>
              </p:grpSpPr>
              <p:cxnSp>
                <p:nvCxnSpPr>
                  <p:cNvPr id="46" name="Straight Arrow Connector 45"/>
                  <p:cNvCxnSpPr/>
                  <p:nvPr/>
                </p:nvCxnSpPr>
                <p:spPr>
                  <a:xfrm>
                    <a:off x="6096000" y="3457575"/>
                    <a:ext cx="8382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6905625" y="3311723"/>
                    <a:ext cx="2696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48" name="Straight Connector 47"/>
                  <p:cNvCxnSpPr/>
                  <p:nvPr/>
                </p:nvCxnSpPr>
                <p:spPr>
                  <a:xfrm flipV="1">
                    <a:off x="7156201" y="3450222"/>
                    <a:ext cx="330449" cy="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Straight Arrow Connector 48"/>
                  <p:cNvCxnSpPr/>
                  <p:nvPr/>
                </p:nvCxnSpPr>
                <p:spPr>
                  <a:xfrm>
                    <a:off x="1699260" y="3794760"/>
                    <a:ext cx="54864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3" name="Group 32"/>
                <p:cNvGrpSpPr/>
                <p:nvPr/>
              </p:nvGrpSpPr>
              <p:grpSpPr>
                <a:xfrm>
                  <a:off x="2247900" y="3659921"/>
                  <a:ext cx="2267010" cy="276999"/>
                  <a:chOff x="2247900" y="3659921"/>
                  <a:chExt cx="2267010" cy="276999"/>
                </a:xfrm>
              </p:grpSpPr>
              <p:cxnSp>
                <p:nvCxnSpPr>
                  <p:cNvPr id="43" name="Straight Arrow Connector 42"/>
                  <p:cNvCxnSpPr/>
                  <p:nvPr/>
                </p:nvCxnSpPr>
                <p:spPr>
                  <a:xfrm>
                    <a:off x="2247900" y="3794760"/>
                    <a:ext cx="972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3190875" y="3659921"/>
                    <a:ext cx="2696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45" name="Straight Arrow Connector 44"/>
                  <p:cNvCxnSpPr/>
                  <p:nvPr/>
                </p:nvCxnSpPr>
                <p:spPr>
                  <a:xfrm>
                    <a:off x="3470910" y="3781425"/>
                    <a:ext cx="1044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4" name="Group 33"/>
                <p:cNvGrpSpPr/>
                <p:nvPr/>
              </p:nvGrpSpPr>
              <p:grpSpPr>
                <a:xfrm>
                  <a:off x="4752525" y="3650396"/>
                  <a:ext cx="2276925" cy="276999"/>
                  <a:chOff x="4752525" y="3650396"/>
                  <a:chExt cx="2276925" cy="276999"/>
                </a:xfrm>
              </p:grpSpPr>
              <p:cxnSp>
                <p:nvCxnSpPr>
                  <p:cNvPr id="40" name="Straight Arrow Connector 39"/>
                  <p:cNvCxnSpPr/>
                  <p:nvPr/>
                </p:nvCxnSpPr>
                <p:spPr>
                  <a:xfrm>
                    <a:off x="4752525" y="3781425"/>
                    <a:ext cx="972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Straight Arrow Connector 40"/>
                  <p:cNvCxnSpPr/>
                  <p:nvPr/>
                </p:nvCxnSpPr>
                <p:spPr>
                  <a:xfrm>
                    <a:off x="5985450" y="3771900"/>
                    <a:ext cx="1044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5686425" y="3650396"/>
                    <a:ext cx="2696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5" name="Group 34"/>
                <p:cNvGrpSpPr/>
                <p:nvPr/>
              </p:nvGrpSpPr>
              <p:grpSpPr>
                <a:xfrm>
                  <a:off x="1676400" y="3771900"/>
                  <a:ext cx="5793300" cy="484494"/>
                  <a:chOff x="1676400" y="3771900"/>
                  <a:chExt cx="5793300" cy="484494"/>
                </a:xfrm>
              </p:grpSpPr>
              <p:cxnSp>
                <p:nvCxnSpPr>
                  <p:cNvPr id="36" name="Straight Arrow Connector 35"/>
                  <p:cNvCxnSpPr/>
                  <p:nvPr/>
                </p:nvCxnSpPr>
                <p:spPr>
                  <a:xfrm>
                    <a:off x="7253700" y="3771900"/>
                    <a:ext cx="216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triangl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Arrow Connector 36"/>
                  <p:cNvCxnSpPr/>
                  <p:nvPr/>
                </p:nvCxnSpPr>
                <p:spPr>
                  <a:xfrm>
                    <a:off x="2143125" y="4105275"/>
                    <a:ext cx="828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1863974" y="3979395"/>
                    <a:ext cx="2696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endPara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9" name="Straight Connector 38"/>
                  <p:cNvCxnSpPr/>
                  <p:nvPr/>
                </p:nvCxnSpPr>
                <p:spPr>
                  <a:xfrm flipV="1">
                    <a:off x="1676400" y="4114799"/>
                    <a:ext cx="180000" cy="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" name="Rectangle 4"/>
              <p:cNvSpPr/>
              <p:nvPr/>
            </p:nvSpPr>
            <p:spPr>
              <a:xfrm>
                <a:off x="1584960" y="3188970"/>
                <a:ext cx="5958840" cy="1440180"/>
              </a:xfrm>
              <a:prstGeom prst="rect">
                <a:avLst/>
              </a:prstGeom>
              <a:noFill/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3" name="Rectangle 2"/>
            <p:cNvSpPr/>
            <p:nvPr/>
          </p:nvSpPr>
          <p:spPr>
            <a:xfrm>
              <a:off x="3705225" y="3933825"/>
              <a:ext cx="752475" cy="18097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1459303" y="2413337"/>
            <a:ext cx="605500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12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3: 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mino acid sequence of </a:t>
            </a:r>
            <a:r>
              <a:rPr lang="en-IN" sz="1200" b="1" i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SR-1 protein denoted in </a:t>
            </a:r>
            <a:r>
              <a:rPr lang="en-IN" sz="12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ingle-letter format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The underlined amino acid sequence shows the conserved domain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of ABA/WDS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protein super family. Four conserved domains 3, 1, 2 and 5 of LEA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roup 7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proteins are displayed in green, red, blue and purple coloured fonts, respectively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. The black coloured box in domain 1 represents the DNA binding domain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900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81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6</cp:revision>
  <dcterms:created xsi:type="dcterms:W3CDTF">2006-08-16T00:00:00Z</dcterms:created>
  <dcterms:modified xsi:type="dcterms:W3CDTF">2015-04-27T06:16:16Z</dcterms:modified>
</cp:coreProperties>
</file>